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14"/>
  </p:normalViewPr>
  <p:slideViewPr>
    <p:cSldViewPr snapToGrid="0" snapToObjects="1">
      <p:cViewPr varScale="1">
        <p:scale>
          <a:sx n="90" d="100"/>
          <a:sy n="90" d="100"/>
        </p:scale>
        <p:origin x="23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heresa2/Desktop/Promotion/Quantitativ/Fertige%20Tabellen:Grafiken/%22Nebenthemen%22/Breastfeeding%20Reason%20&amp;%20Sens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/>
              <a:t>Breastfeeding is...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Sensation of breastfeeding'!$C$1</c:f>
              <c:strCache>
                <c:ptCount val="1"/>
                <c:pt idx="0">
                  <c:v>Strongly agre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'Sensation of breastfeeding'!$A$2:$B$32</c:f>
              <c:multiLvlStrCache>
                <c:ptCount val="31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  <c:pt idx="28">
                    <c:v>t3</c:v>
                  </c:pt>
                  <c:pt idx="29">
                    <c:v>t2</c:v>
                  </c:pt>
                  <c:pt idx="30">
                    <c:v>t1</c:v>
                  </c:pt>
                </c:lvl>
                <c:lvl>
                  <c:pt idx="0">
                    <c:v>Difficult to give up alcohol/ smoking</c:v>
                  </c:pt>
                  <c:pt idx="4">
                    <c:v>Painful</c:v>
                  </c:pt>
                  <c:pt idx="8">
                    <c:v>Exhausting</c:v>
                  </c:pt>
                  <c:pt idx="12">
                    <c:v>Restricts independence</c:v>
                  </c:pt>
                  <c:pt idx="16">
                    <c:v>Time consuming</c:v>
                  </c:pt>
                  <c:pt idx="20">
                    <c:v>Practical</c:v>
                  </c:pt>
                  <c:pt idx="24">
                    <c:v>Enjoyable</c:v>
                  </c:pt>
                  <c:pt idx="28">
                    <c:v>Pleasant</c:v>
                  </c:pt>
                </c:lvl>
              </c:multiLvlStrCache>
            </c:multiLvlStrRef>
          </c:cat>
          <c:val>
            <c:numRef>
              <c:f>'Sensation of breastfeeding'!$C$2:$C$32</c:f>
              <c:numCache>
                <c:formatCode>0.0%</c:formatCode>
                <c:ptCount val="31"/>
                <c:pt idx="0">
                  <c:v>2.4E-2</c:v>
                </c:pt>
                <c:pt idx="1">
                  <c:v>0</c:v>
                </c:pt>
                <c:pt idx="2">
                  <c:v>0.01</c:v>
                </c:pt>
                <c:pt idx="4">
                  <c:v>1.6E-2</c:v>
                </c:pt>
                <c:pt idx="5">
                  <c:v>0</c:v>
                </c:pt>
                <c:pt idx="6">
                  <c:v>6.4000000000000001E-2</c:v>
                </c:pt>
                <c:pt idx="8">
                  <c:v>0.10299999999999999</c:v>
                </c:pt>
                <c:pt idx="9">
                  <c:v>9.2999999999999999E-2</c:v>
                </c:pt>
                <c:pt idx="10">
                  <c:v>0.108</c:v>
                </c:pt>
                <c:pt idx="12">
                  <c:v>0.214</c:v>
                </c:pt>
                <c:pt idx="13">
                  <c:v>0.20899999999999999</c:v>
                </c:pt>
                <c:pt idx="14">
                  <c:v>0.29399999999999998</c:v>
                </c:pt>
                <c:pt idx="16">
                  <c:v>9.5000000000000001E-2</c:v>
                </c:pt>
                <c:pt idx="17">
                  <c:v>0.13700000000000001</c:v>
                </c:pt>
                <c:pt idx="18">
                  <c:v>0.31900000000000001</c:v>
                </c:pt>
                <c:pt idx="20">
                  <c:v>0.63</c:v>
                </c:pt>
                <c:pt idx="21">
                  <c:v>0.61</c:v>
                </c:pt>
                <c:pt idx="22">
                  <c:v>0.51</c:v>
                </c:pt>
                <c:pt idx="24">
                  <c:v>0.16500000000000001</c:v>
                </c:pt>
                <c:pt idx="25">
                  <c:v>0.121</c:v>
                </c:pt>
                <c:pt idx="26">
                  <c:v>0.123</c:v>
                </c:pt>
                <c:pt idx="28">
                  <c:v>0.15</c:v>
                </c:pt>
                <c:pt idx="29">
                  <c:v>0.20399999999999999</c:v>
                </c:pt>
                <c:pt idx="30">
                  <c:v>0.1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68-7840-A6D5-452CDE560E53}"/>
            </c:ext>
          </c:extLst>
        </c:ser>
        <c:ser>
          <c:idx val="1"/>
          <c:order val="1"/>
          <c:tx>
            <c:strRef>
              <c:f>'Sensation of breastfeeding'!$D$1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Sensation of breastfeeding'!$A$2:$B$32</c:f>
              <c:multiLvlStrCache>
                <c:ptCount val="31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  <c:pt idx="28">
                    <c:v>t3</c:v>
                  </c:pt>
                  <c:pt idx="29">
                    <c:v>t2</c:v>
                  </c:pt>
                  <c:pt idx="30">
                    <c:v>t1</c:v>
                  </c:pt>
                </c:lvl>
                <c:lvl>
                  <c:pt idx="0">
                    <c:v>Difficult to give up alcohol/ smoking</c:v>
                  </c:pt>
                  <c:pt idx="4">
                    <c:v>Painful</c:v>
                  </c:pt>
                  <c:pt idx="8">
                    <c:v>Exhausting</c:v>
                  </c:pt>
                  <c:pt idx="12">
                    <c:v>Restricts independence</c:v>
                  </c:pt>
                  <c:pt idx="16">
                    <c:v>Time consuming</c:v>
                  </c:pt>
                  <c:pt idx="20">
                    <c:v>Practical</c:v>
                  </c:pt>
                  <c:pt idx="24">
                    <c:v>Enjoyable</c:v>
                  </c:pt>
                  <c:pt idx="28">
                    <c:v>Pleasant</c:v>
                  </c:pt>
                </c:lvl>
              </c:multiLvlStrCache>
            </c:multiLvlStrRef>
          </c:cat>
          <c:val>
            <c:numRef>
              <c:f>'Sensation of breastfeeding'!$D$2:$D$32</c:f>
              <c:numCache>
                <c:formatCode>0.0%</c:formatCode>
                <c:ptCount val="31"/>
                <c:pt idx="0">
                  <c:v>3.9E-2</c:v>
                </c:pt>
                <c:pt idx="1">
                  <c:v>6.6000000000000003E-2</c:v>
                </c:pt>
                <c:pt idx="2">
                  <c:v>5.3999999999999999E-2</c:v>
                </c:pt>
                <c:pt idx="4">
                  <c:v>0.04</c:v>
                </c:pt>
                <c:pt idx="5">
                  <c:v>3.9E-2</c:v>
                </c:pt>
                <c:pt idx="6">
                  <c:v>8.7999999999999995E-2</c:v>
                </c:pt>
                <c:pt idx="8">
                  <c:v>0.28599999999999998</c:v>
                </c:pt>
                <c:pt idx="9">
                  <c:v>0.29699999999999999</c:v>
                </c:pt>
                <c:pt idx="10">
                  <c:v>0.30399999999999999</c:v>
                </c:pt>
                <c:pt idx="12">
                  <c:v>0.34100000000000003</c:v>
                </c:pt>
                <c:pt idx="13">
                  <c:v>0.35699999999999998</c:v>
                </c:pt>
                <c:pt idx="14">
                  <c:v>0.31900000000000001</c:v>
                </c:pt>
                <c:pt idx="16">
                  <c:v>0.20599999999999999</c:v>
                </c:pt>
                <c:pt idx="17">
                  <c:v>0.28000000000000003</c:v>
                </c:pt>
                <c:pt idx="18">
                  <c:v>0.32800000000000001</c:v>
                </c:pt>
                <c:pt idx="20">
                  <c:v>0.29099999999999998</c:v>
                </c:pt>
                <c:pt idx="21">
                  <c:v>0.28599999999999998</c:v>
                </c:pt>
                <c:pt idx="22">
                  <c:v>0.309</c:v>
                </c:pt>
                <c:pt idx="24">
                  <c:v>0.40899999999999997</c:v>
                </c:pt>
                <c:pt idx="25">
                  <c:v>0.39600000000000002</c:v>
                </c:pt>
                <c:pt idx="26">
                  <c:v>0.29399999999999998</c:v>
                </c:pt>
                <c:pt idx="28">
                  <c:v>0.44900000000000001</c:v>
                </c:pt>
                <c:pt idx="29">
                  <c:v>0.43099999999999999</c:v>
                </c:pt>
                <c:pt idx="30">
                  <c:v>0.36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68-7840-A6D5-452CDE560E53}"/>
            </c:ext>
          </c:extLst>
        </c:ser>
        <c:ser>
          <c:idx val="2"/>
          <c:order val="2"/>
          <c:tx>
            <c:strRef>
              <c:f>'Sensation of breastfeeding'!$E$1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Sensation of breastfeeding'!$A$2:$B$32</c:f>
              <c:multiLvlStrCache>
                <c:ptCount val="31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  <c:pt idx="28">
                    <c:v>t3</c:v>
                  </c:pt>
                  <c:pt idx="29">
                    <c:v>t2</c:v>
                  </c:pt>
                  <c:pt idx="30">
                    <c:v>t1</c:v>
                  </c:pt>
                </c:lvl>
                <c:lvl>
                  <c:pt idx="0">
                    <c:v>Difficult to give up alcohol/ smoking</c:v>
                  </c:pt>
                  <c:pt idx="4">
                    <c:v>Painful</c:v>
                  </c:pt>
                  <c:pt idx="8">
                    <c:v>Exhausting</c:v>
                  </c:pt>
                  <c:pt idx="12">
                    <c:v>Restricts independence</c:v>
                  </c:pt>
                  <c:pt idx="16">
                    <c:v>Time consuming</c:v>
                  </c:pt>
                  <c:pt idx="20">
                    <c:v>Practical</c:v>
                  </c:pt>
                  <c:pt idx="24">
                    <c:v>Enjoyable</c:v>
                  </c:pt>
                  <c:pt idx="28">
                    <c:v>Pleasant</c:v>
                  </c:pt>
                </c:lvl>
              </c:multiLvlStrCache>
            </c:multiLvlStrRef>
          </c:cat>
          <c:val>
            <c:numRef>
              <c:f>'Sensation of breastfeeding'!$E$2:$E$32</c:f>
              <c:numCache>
                <c:formatCode>0.0%</c:formatCode>
                <c:ptCount val="31"/>
                <c:pt idx="0">
                  <c:v>0.14199999999999999</c:v>
                </c:pt>
                <c:pt idx="1">
                  <c:v>0.18099999999999999</c:v>
                </c:pt>
                <c:pt idx="2">
                  <c:v>0.16700000000000001</c:v>
                </c:pt>
                <c:pt idx="4">
                  <c:v>0.34100000000000003</c:v>
                </c:pt>
                <c:pt idx="5">
                  <c:v>0.32</c:v>
                </c:pt>
                <c:pt idx="6">
                  <c:v>0.41199999999999998</c:v>
                </c:pt>
                <c:pt idx="8">
                  <c:v>0.32500000000000001</c:v>
                </c:pt>
                <c:pt idx="9">
                  <c:v>0.33</c:v>
                </c:pt>
                <c:pt idx="10">
                  <c:v>0.34799999999999998</c:v>
                </c:pt>
                <c:pt idx="12">
                  <c:v>0.29399999999999998</c:v>
                </c:pt>
                <c:pt idx="13">
                  <c:v>0.29699999999999999</c:v>
                </c:pt>
                <c:pt idx="14">
                  <c:v>0.24</c:v>
                </c:pt>
                <c:pt idx="16">
                  <c:v>0.31</c:v>
                </c:pt>
                <c:pt idx="17">
                  <c:v>0.247</c:v>
                </c:pt>
                <c:pt idx="18">
                  <c:v>0.22500000000000001</c:v>
                </c:pt>
                <c:pt idx="20">
                  <c:v>7.0999999999999994E-2</c:v>
                </c:pt>
                <c:pt idx="21">
                  <c:v>0.104</c:v>
                </c:pt>
                <c:pt idx="22">
                  <c:v>0.152</c:v>
                </c:pt>
                <c:pt idx="24">
                  <c:v>0.378</c:v>
                </c:pt>
                <c:pt idx="25">
                  <c:v>0.42299999999999999</c:v>
                </c:pt>
                <c:pt idx="26">
                  <c:v>0.42199999999999999</c:v>
                </c:pt>
                <c:pt idx="28">
                  <c:v>0.34599999999999997</c:v>
                </c:pt>
                <c:pt idx="29">
                  <c:v>0.33100000000000002</c:v>
                </c:pt>
                <c:pt idx="30">
                  <c:v>0.3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468-7840-A6D5-452CDE560E53}"/>
            </c:ext>
          </c:extLst>
        </c:ser>
        <c:ser>
          <c:idx val="3"/>
          <c:order val="3"/>
          <c:tx>
            <c:strRef>
              <c:f>'Sensation of breastfeeding'!$F$1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rgbClr val="C00000">
                <a:alpha val="50000"/>
              </a:srgbClr>
            </a:solidFill>
            <a:ln>
              <a:noFill/>
            </a:ln>
            <a:effectLst/>
          </c:spPr>
          <c:invertIfNegative val="0"/>
          <c:cat>
            <c:multiLvlStrRef>
              <c:f>'Sensation of breastfeeding'!$A$2:$B$32</c:f>
              <c:multiLvlStrCache>
                <c:ptCount val="31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  <c:pt idx="28">
                    <c:v>t3</c:v>
                  </c:pt>
                  <c:pt idx="29">
                    <c:v>t2</c:v>
                  </c:pt>
                  <c:pt idx="30">
                    <c:v>t1</c:v>
                  </c:pt>
                </c:lvl>
                <c:lvl>
                  <c:pt idx="0">
                    <c:v>Difficult to give up alcohol/ smoking</c:v>
                  </c:pt>
                  <c:pt idx="4">
                    <c:v>Painful</c:v>
                  </c:pt>
                  <c:pt idx="8">
                    <c:v>Exhausting</c:v>
                  </c:pt>
                  <c:pt idx="12">
                    <c:v>Restricts independence</c:v>
                  </c:pt>
                  <c:pt idx="16">
                    <c:v>Time consuming</c:v>
                  </c:pt>
                  <c:pt idx="20">
                    <c:v>Practical</c:v>
                  </c:pt>
                  <c:pt idx="24">
                    <c:v>Enjoyable</c:v>
                  </c:pt>
                  <c:pt idx="28">
                    <c:v>Pleasant</c:v>
                  </c:pt>
                </c:lvl>
              </c:multiLvlStrCache>
            </c:multiLvlStrRef>
          </c:cat>
          <c:val>
            <c:numRef>
              <c:f>'Sensation of breastfeeding'!$F$2:$F$32</c:f>
              <c:numCache>
                <c:formatCode>0.0%</c:formatCode>
                <c:ptCount val="31"/>
                <c:pt idx="0">
                  <c:v>0.26</c:v>
                </c:pt>
                <c:pt idx="1">
                  <c:v>0.28599999999999998</c:v>
                </c:pt>
                <c:pt idx="2">
                  <c:v>0.23</c:v>
                </c:pt>
                <c:pt idx="4">
                  <c:v>0.33300000000000002</c:v>
                </c:pt>
                <c:pt idx="5">
                  <c:v>0.34300000000000003</c:v>
                </c:pt>
                <c:pt idx="6">
                  <c:v>0.255</c:v>
                </c:pt>
                <c:pt idx="8">
                  <c:v>0.214</c:v>
                </c:pt>
                <c:pt idx="9">
                  <c:v>0.20300000000000001</c:v>
                </c:pt>
                <c:pt idx="10">
                  <c:v>0.157</c:v>
                </c:pt>
                <c:pt idx="12">
                  <c:v>0.11899999999999999</c:v>
                </c:pt>
                <c:pt idx="13">
                  <c:v>9.2999999999999999E-2</c:v>
                </c:pt>
                <c:pt idx="14">
                  <c:v>0.108</c:v>
                </c:pt>
                <c:pt idx="16">
                  <c:v>0.32500000000000001</c:v>
                </c:pt>
                <c:pt idx="17">
                  <c:v>0.25800000000000001</c:v>
                </c:pt>
                <c:pt idx="18">
                  <c:v>9.2999999999999999E-2</c:v>
                </c:pt>
                <c:pt idx="20">
                  <c:v>8.0000000000000002E-3</c:v>
                </c:pt>
                <c:pt idx="21">
                  <c:v>0</c:v>
                </c:pt>
                <c:pt idx="22">
                  <c:v>2.9000000000000001E-2</c:v>
                </c:pt>
                <c:pt idx="24">
                  <c:v>4.7E-2</c:v>
                </c:pt>
                <c:pt idx="25">
                  <c:v>4.9000000000000002E-2</c:v>
                </c:pt>
                <c:pt idx="26">
                  <c:v>0.14699999999999999</c:v>
                </c:pt>
                <c:pt idx="28">
                  <c:v>4.7E-2</c:v>
                </c:pt>
                <c:pt idx="29">
                  <c:v>2.8000000000000001E-2</c:v>
                </c:pt>
                <c:pt idx="30">
                  <c:v>0.10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468-7840-A6D5-452CDE560E53}"/>
            </c:ext>
          </c:extLst>
        </c:ser>
        <c:ser>
          <c:idx val="4"/>
          <c:order val="4"/>
          <c:tx>
            <c:strRef>
              <c:f>'Sensation of breastfeeding'!$G$1</c:f>
              <c:strCache>
                <c:ptCount val="1"/>
                <c:pt idx="0">
                  <c:v>Strongly disagre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multiLvlStrRef>
              <c:f>'Sensation of breastfeeding'!$A$2:$B$32</c:f>
              <c:multiLvlStrCache>
                <c:ptCount val="31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  <c:pt idx="28">
                    <c:v>t3</c:v>
                  </c:pt>
                  <c:pt idx="29">
                    <c:v>t2</c:v>
                  </c:pt>
                  <c:pt idx="30">
                    <c:v>t1</c:v>
                  </c:pt>
                </c:lvl>
                <c:lvl>
                  <c:pt idx="0">
                    <c:v>Difficult to give up alcohol/ smoking</c:v>
                  </c:pt>
                  <c:pt idx="4">
                    <c:v>Painful</c:v>
                  </c:pt>
                  <c:pt idx="8">
                    <c:v>Exhausting</c:v>
                  </c:pt>
                  <c:pt idx="12">
                    <c:v>Restricts independence</c:v>
                  </c:pt>
                  <c:pt idx="16">
                    <c:v>Time consuming</c:v>
                  </c:pt>
                  <c:pt idx="20">
                    <c:v>Practical</c:v>
                  </c:pt>
                  <c:pt idx="24">
                    <c:v>Enjoyable</c:v>
                  </c:pt>
                  <c:pt idx="28">
                    <c:v>Pleasant</c:v>
                  </c:pt>
                </c:lvl>
              </c:multiLvlStrCache>
            </c:multiLvlStrRef>
          </c:cat>
          <c:val>
            <c:numRef>
              <c:f>'Sensation of breastfeeding'!$G$2:$G$32</c:f>
              <c:numCache>
                <c:formatCode>0.0%</c:formatCode>
                <c:ptCount val="31"/>
                <c:pt idx="0">
                  <c:v>0.53500000000000003</c:v>
                </c:pt>
                <c:pt idx="1">
                  <c:v>0.46700000000000003</c:v>
                </c:pt>
                <c:pt idx="2">
                  <c:v>0.53900000000000003</c:v>
                </c:pt>
                <c:pt idx="4">
                  <c:v>0.27</c:v>
                </c:pt>
                <c:pt idx="5">
                  <c:v>0.29799999999999999</c:v>
                </c:pt>
                <c:pt idx="6">
                  <c:v>0.18099999999999999</c:v>
                </c:pt>
                <c:pt idx="8">
                  <c:v>7.0999999999999994E-2</c:v>
                </c:pt>
                <c:pt idx="9">
                  <c:v>7.6999999999999999E-2</c:v>
                </c:pt>
                <c:pt idx="10">
                  <c:v>8.3000000000000004E-2</c:v>
                </c:pt>
                <c:pt idx="12">
                  <c:v>3.2000000000000001E-2</c:v>
                </c:pt>
                <c:pt idx="13">
                  <c:v>4.3999999999999997E-2</c:v>
                </c:pt>
                <c:pt idx="14">
                  <c:v>3.9E-2</c:v>
                </c:pt>
                <c:pt idx="16">
                  <c:v>6.3E-2</c:v>
                </c:pt>
                <c:pt idx="17">
                  <c:v>7.6999999999999999E-2</c:v>
                </c:pt>
                <c:pt idx="18">
                  <c:v>3.4000000000000002E-2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4">
                  <c:v>0</c:v>
                </c:pt>
                <c:pt idx="25">
                  <c:v>1.0999999999999999E-2</c:v>
                </c:pt>
                <c:pt idx="26">
                  <c:v>1.4999999999999999E-2</c:v>
                </c:pt>
                <c:pt idx="28">
                  <c:v>8.0000000000000002E-3</c:v>
                </c:pt>
                <c:pt idx="29">
                  <c:v>6.0000000000000001E-3</c:v>
                </c:pt>
                <c:pt idx="30">
                  <c:v>0.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468-7840-A6D5-452CDE560E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46537647"/>
        <c:axId val="2099563039"/>
      </c:barChart>
      <c:catAx>
        <c:axId val="204653764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0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99563039"/>
        <c:crosses val="autoZero"/>
        <c:auto val="1"/>
        <c:lblAlgn val="ctr"/>
        <c:lblOffset val="100"/>
        <c:noMultiLvlLbl val="0"/>
      </c:catAx>
      <c:valAx>
        <c:axId val="209956303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465376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371DB5-B7E4-914F-839A-3B49DB7296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EEA45FD-BDE6-FA40-B1DC-EB86DB2E30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8726F6-0092-8842-8FA1-0E3FEC859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D20F7C-9F34-B644-BF77-DF3E6A1A6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1E1F33E-43AE-C64D-AD6B-9BA224EBE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0064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42B6F4-9D62-3B4B-9A83-147EC787D9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0675A93-C8DB-084D-AE76-6FDB64A358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5B0728-CBBD-104F-9A90-3EDF84E6E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5AC2E3-EF5E-B34C-9829-28EA4F37A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0171B07-0D88-6847-86FF-9AC4B3D43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3200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32F0E31-BFF3-DF4F-93FB-BD648EF482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658C211-719F-D149-87E4-C6CA631C94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4A4EF64-C241-5A47-BA37-C58C921F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9B4C15A-1CFF-9246-9CF8-C99A6B1B6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C9B1736-31FC-DD44-87EA-E8117E672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8736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FCECAC-A37B-E847-B8C6-C9D7933A6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58955A-176F-414A-B70D-A8363A75AB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726D7E-3F80-6741-962D-B87D6D085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006032E-5254-E644-8C5C-8650F8D0A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D46C7D7-EE4B-264C-BA89-E5FFA545A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8248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DBFC41-B892-5041-B38A-898503DD7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F1E7696-50E2-3E43-BA0A-9488E5FB27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66EED6-278A-004F-827C-D0CC9590B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B712552-B960-614F-9EA7-F6D466676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333063-8CEA-D544-98F8-6ABB454DE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364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4D5C7F-EE86-E54F-AC1A-7EDCC9A97F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83FE666-A78E-9C45-98EB-6A0414AB10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F8EE852-317E-0141-BB10-AC8D766085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C39FE57-5190-E941-AE0B-DF11B52E3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E3C3FF6-6BA3-0240-B82A-FBCF0D531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B96C3E4-5174-5C46-BD47-AA65A01F6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7972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F0314C-C5E7-4E4F-9204-B5A4C14EA5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491DC7A-7603-E846-B78F-E11290522D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45F3860-1670-4D48-B903-5A6FB60F6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819B095-4153-7B48-A50E-C10E4913EF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FD5E581-F035-744A-B045-0835FAB643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2E93AC6-7E10-444B-A4B3-479FA38E0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E56E3B5-0FF6-0F4E-A594-3A53BFEA0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51ED60D-DE48-6E47-946C-C78492269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8312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AB18D51-26C8-1C4C-AA80-584C548E6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D6C3F16-59B0-CC4E-93DF-2CB70566C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427BF5F-44E2-504B-BEF3-D998008E2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F40B97D-7716-D548-83FA-677F4BAEB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098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23C6F64-D160-2446-A455-3E3623D64A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CE9DBB8-E4E5-4847-9E39-A144903C1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63ADA0D-E0A5-AD4F-A6AE-89210E2425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1411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D38D2C-F2C0-1C42-97AB-FFA59FAA11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06C9126-BAE9-6A4E-827D-436D5C86A6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2E62DBD-CE63-4041-9C34-FEA7FCE826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155F92-F576-AA49-95E0-0AF80C299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6BAD46B-EB3D-7547-8154-DE1412A6A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EEF33AA-BD80-3648-85DA-616BA2B95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5406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E93BED-7DE5-F242-AF1B-A2956B0CD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93CAFED-BD43-2E46-8C89-1D9843B44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540A8EF-07E0-2848-88A3-95766F5F3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8BE9EEB-21A8-7743-BB08-F9565AB0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2F4A8CE-F0F8-314E-BC25-2B0C1B2A6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61EA250-3F07-9A44-953A-427E24C21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3643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AB60130-1CA5-824C-B739-E5CA3C5F7F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C122D84-6FF7-DD45-89C1-8EC3FC1D1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52C8E79-08DB-3847-9DD8-112CB5CB2B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DBAC8-C8E2-3D49-9669-5A2A81D738DB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B6ED692-846D-4348-B8FC-AAF5FCD448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561F7BC-0366-724C-ADF3-E89D822A52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2FCB4-28E2-A64E-BC0C-E415295F40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304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>
            <a:extLst>
              <a:ext uri="{FF2B5EF4-FFF2-40B4-BE49-F238E27FC236}">
                <a16:creationId xmlns:a16="http://schemas.microsoft.com/office/drawing/2014/main" id="{02FB40A6-B3AD-A446-B005-94118C757E3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46878945"/>
              </p:ext>
            </p:extLst>
          </p:nvPr>
        </p:nvGraphicFramePr>
        <p:xfrm>
          <a:off x="838200" y="214312"/>
          <a:ext cx="10515600" cy="64293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72429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</Words>
  <Application>Microsoft Macintosh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rtlmaier, Theresa Philomena</dc:creator>
  <cp:lastModifiedBy>Ertlmaier, Theresa Philomena</cp:lastModifiedBy>
  <cp:revision>1</cp:revision>
  <dcterms:created xsi:type="dcterms:W3CDTF">2025-03-30T15:05:10Z</dcterms:created>
  <dcterms:modified xsi:type="dcterms:W3CDTF">2025-03-30T15:13:07Z</dcterms:modified>
</cp:coreProperties>
</file>